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2"/>
  </p:notesMasterIdLst>
  <p:sldIdLst>
    <p:sldId id="1086" r:id="rId2"/>
    <p:sldId id="1073" r:id="rId3"/>
    <p:sldId id="1080" r:id="rId4"/>
    <p:sldId id="1084" r:id="rId5"/>
    <p:sldId id="1077" r:id="rId6"/>
    <p:sldId id="1075" r:id="rId7"/>
    <p:sldId id="1085" r:id="rId8"/>
    <p:sldId id="1083" r:id="rId9"/>
    <p:sldId id="1058" r:id="rId10"/>
    <p:sldId id="1078" r:id="rId11"/>
  </p:sldIdLst>
  <p:sldSz cx="18288000" cy="10287000"/>
  <p:notesSz cx="6858000" cy="9144000"/>
  <p:embeddedFontLst>
    <p:embeddedFont>
      <p:font typeface="Assistant" pitchFamily="2" charset="-79"/>
      <p:regular r:id="rId13"/>
      <p:bold r:id="rId14"/>
    </p:embeddedFont>
    <p:embeddedFont>
      <p:font typeface="Assistant Bold" charset="-79"/>
      <p:regular r:id="rId15"/>
      <p:bold r:id="rId16"/>
    </p:embeddedFont>
    <p:embeddedFont>
      <p:font typeface="Assistant ExtraBold" pitchFamily="2" charset="-79"/>
      <p:bold r:id="rId17"/>
    </p:embeddedFont>
    <p:embeddedFont>
      <p:font typeface="Assistant Regular" charset="-79"/>
      <p:regular r:id="rId18"/>
    </p:embeddedFont>
    <p:embeddedFont>
      <p:font typeface="Assistant SemiBold" pitchFamily="2" charset="-79"/>
      <p:bold r:id="rId19"/>
    </p:embeddedFont>
    <p:embeddedFont>
      <p:font typeface="Calibri" panose="020F0502020204030204" pitchFamily="34" charset="0"/>
      <p:regular r:id="rId20"/>
      <p:bold r:id="rId21"/>
      <p:italic r:id="rId22"/>
      <p:boldItalic r:id="rId23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1.fntdata"/><Relationship Id="rId18" Type="http://schemas.openxmlformats.org/officeDocument/2006/relationships/font" Target="fonts/font6.fntdata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font" Target="fonts/font9.fntdata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font" Target="fonts/font5.fntdata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font" Target="fonts/font4.fntdata"/><Relationship Id="rId20" Type="http://schemas.openxmlformats.org/officeDocument/2006/relationships/font" Target="fonts/font8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font" Target="fonts/font3.fntdata"/><Relationship Id="rId23" Type="http://schemas.openxmlformats.org/officeDocument/2006/relationships/font" Target="fonts/font11.fntdata"/><Relationship Id="rId10" Type="http://schemas.openxmlformats.org/officeDocument/2006/relationships/slide" Target="slides/slide9.xml"/><Relationship Id="rId19" Type="http://schemas.openxmlformats.org/officeDocument/2006/relationships/font" Target="fonts/font7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2.fntdata"/><Relationship Id="rId22" Type="http://schemas.openxmlformats.org/officeDocument/2006/relationships/font" Target="fonts/font10.fntdata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542719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3353326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22125431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6184241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19511650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svg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3362149"/>
            <a:chOff x="1573698" y="-152998"/>
            <a:chExt cx="7219847" cy="2602807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2462212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WEEK #5</a:t>
              </a:r>
            </a:p>
            <a:p>
              <a:pPr marL="0" lvl="0" indent="0" algn="ctr">
                <a:spcBef>
                  <a:spcPct val="0"/>
                </a:spcBef>
              </a:pPr>
              <a:endParaRPr lang="en-US" sz="3000" spc="874" dirty="0">
                <a:solidFill>
                  <a:schemeClr val="tx1">
                    <a:lumMod val="65000"/>
                    <a:lumOff val="35000"/>
                  </a:schemeClr>
                </a:solidFill>
                <a:latin typeface="Assistant SemiBold" panose="020B0604020202020204" pitchFamily="2" charset="-79"/>
                <a:cs typeface="Assistant SemiBold" panose="020B0604020202020204" pitchFamily="2" charset="-79"/>
              </a:endParaRP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TIP THE CALORIE BALANCE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1870958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week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rink water when you feel hungry between me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step count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9895" y="7962900"/>
            <a:ext cx="11554505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The calorie balance can work for you, keep trying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Check that scale everyday but focus on weekly trends, you got this!</a:t>
            </a:r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WEEK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weight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get some brisk-paced walking in, and remember to breathe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give your meals a healthy makeover?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en were the most active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29256" y="2367826"/>
            <a:ext cx="10479651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eekday morning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eekday afternoon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eekday evening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eekend morning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eekend afternoon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eekday evening</a:t>
            </a:r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057400" y="8642746"/>
            <a:ext cx="15468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SHARE YOUR STRATEGIES FOR SUCCESS IN THE CHAT!</a:t>
            </a:r>
          </a:p>
          <a:p>
            <a:r>
              <a:rPr lang="en-US" sz="2800" dirty="0"/>
              <a:t>Were you more likely to be active when alone or bored, or when others wanted to get moving?</a:t>
            </a:r>
          </a:p>
          <a:p>
            <a:r>
              <a:rPr lang="en-US" sz="2800" dirty="0"/>
              <a:t>Let the group know what works for you --  it could really help others find motivation and success!</a:t>
            </a:r>
          </a:p>
          <a:p>
            <a:endParaRPr lang="en-US" sz="2000" dirty="0"/>
          </a:p>
        </p:txBody>
      </p:sp>
      <p:pic>
        <p:nvPicPr>
          <p:cNvPr id="5" name="Graphic 4" descr="Cheers with solid fill">
            <a:extLst>
              <a:ext uri="{FF2B5EF4-FFF2-40B4-BE49-F238E27FC236}">
                <a16:creationId xmlns:a16="http://schemas.microsoft.com/office/drawing/2014/main" id="{E453062F-0802-4E53-B731-7167D3C0EE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31914" y="8642746"/>
            <a:ext cx="1449285" cy="14492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8102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do you feel after you get moving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59375" y="1475793"/>
            <a:ext cx="10479651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does healthy feel like to  you? (select all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have more energy after a good walk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sleep better, and wake rested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am less hungr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have had a better moo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look forward to my next walk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family says they are noticing the differenc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My clothes fit bett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Getting my steps in is getting easi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5F599F-1C10-4D78-B583-3855FC96B18E}"/>
              </a:ext>
            </a:extLst>
          </p:cNvPr>
          <p:cNvSpPr txBox="1"/>
          <p:nvPr/>
        </p:nvSpPr>
        <p:spPr>
          <a:xfrm>
            <a:off x="2112526" y="8933563"/>
            <a:ext cx="15468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IM FOR SUCCESS </a:t>
            </a:r>
          </a:p>
          <a:p>
            <a:r>
              <a:rPr lang="en-US" sz="2400" dirty="0"/>
              <a:t>Those milestones are important to recognize and build on!</a:t>
            </a:r>
          </a:p>
          <a:p>
            <a:endParaRPr lang="en-US" sz="2000" dirty="0"/>
          </a:p>
        </p:txBody>
      </p:sp>
      <p:pic>
        <p:nvPicPr>
          <p:cNvPr id="14" name="Graphic 13" descr="Bullseye outline">
            <a:extLst>
              <a:ext uri="{FF2B5EF4-FFF2-40B4-BE49-F238E27FC236}">
                <a16:creationId xmlns:a16="http://schemas.microsoft.com/office/drawing/2014/main" id="{5B8093DA-18FA-4818-A56E-621677A890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07984" y="8756910"/>
            <a:ext cx="1380593" cy="1380593"/>
          </a:xfrm>
          <a:prstGeom prst="rect">
            <a:avLst/>
          </a:prstGeom>
        </p:spPr>
      </p:pic>
      <p:pic>
        <p:nvPicPr>
          <p:cNvPr id="2052" name="Picture 4" descr="How to set and achieve project milestones in Teamwork Projects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43946" y="3390900"/>
            <a:ext cx="6739467" cy="3790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240511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The Calorie Balan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524000" y="1839730"/>
            <a:ext cx="12086744" cy="8679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u="sng" dirty="0"/>
              <a:t>What is a calorie?</a:t>
            </a:r>
          </a:p>
          <a:p>
            <a:pPr marL="457200" indent="-457200">
              <a:buFont typeface="Wingdings" panose="05000000000000000000" pitchFamily="2" charset="2"/>
              <a:buChar char="à"/>
            </a:pPr>
            <a:r>
              <a:rPr lang="en-US" sz="3000" dirty="0"/>
              <a:t>The amount of energy in a food – energy you need</a:t>
            </a:r>
          </a:p>
          <a:p>
            <a:r>
              <a:rPr lang="en-US" sz="3000" dirty="0"/>
              <a:t>	to fuel your day.</a:t>
            </a:r>
          </a:p>
          <a:p>
            <a:pPr marL="457200" indent="-457200">
              <a:buFont typeface="Wingdings" panose="05000000000000000000" pitchFamily="2" charset="2"/>
              <a:buChar char="à"/>
            </a:pPr>
            <a:r>
              <a:rPr lang="en-US" sz="3000" dirty="0"/>
              <a:t>Calories in food are from </a:t>
            </a:r>
          </a:p>
          <a:p>
            <a:pPr lvl="1"/>
            <a:r>
              <a:rPr lang="en-US" sz="3000" dirty="0"/>
              <a:t>Fat, carbohydrates, protein or alcohol</a:t>
            </a:r>
            <a:endParaRPr lang="en-US" sz="3000" b="1" u="sng" dirty="0"/>
          </a:p>
          <a:p>
            <a:endParaRPr lang="en-US" sz="3200" b="1" u="sng" dirty="0"/>
          </a:p>
          <a:p>
            <a:r>
              <a:rPr lang="en-US" sz="3200" b="1" u="sng" dirty="0"/>
              <a:t>Calories in, Calories Out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What you eat is your calories IN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What you burn walking is your calories OUT 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Budgeting calories is the best way to shed pound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Your daily steps keep those pounds off</a:t>
            </a:r>
          </a:p>
          <a:p>
            <a:pPr marL="914400" lvl="1" indent="-457200">
              <a:buFontTx/>
              <a:buChar char="-"/>
            </a:pPr>
            <a:endParaRPr lang="en-US" sz="2000" dirty="0"/>
          </a:p>
          <a:p>
            <a:pPr marL="914400" lvl="1" indent="-457200">
              <a:buFontTx/>
              <a:buChar char="-"/>
            </a:pPr>
            <a:endParaRPr lang="en-US" sz="2000" dirty="0"/>
          </a:p>
          <a:p>
            <a:r>
              <a:rPr lang="en-US" sz="3200" b="1" u="sng" dirty="0"/>
              <a:t>Ways to tip the calorie Calorie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Eat more fiber, and multiple times a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Eat less fat, especially saturated fat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Don’t drink your calorie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3000" dirty="0"/>
              <a:t>Walk more, walk faster (if you can)</a:t>
            </a:r>
          </a:p>
          <a:p>
            <a:pPr marL="914400" lvl="1" indent="-457200">
              <a:buFontTx/>
              <a:buChar char="-"/>
            </a:pPr>
            <a:endParaRPr lang="en-US" sz="3000" dirty="0"/>
          </a:p>
        </p:txBody>
      </p:sp>
      <p:pic>
        <p:nvPicPr>
          <p:cNvPr id="1028" name="Picture 4" descr="Balance of healthy and unhealthy food Royalty Free Vector">
            <a:extLst>
              <a:ext uri="{FF2B5EF4-FFF2-40B4-BE49-F238E27FC236}">
                <a16:creationId xmlns:a16="http://schemas.microsoft.com/office/drawing/2014/main" id="{99DA458E-077A-4B97-9F1C-A80BE8F1013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9" t="16008" r="3600" b="20256"/>
          <a:stretch/>
        </p:blipFill>
        <p:spPr bwMode="auto">
          <a:xfrm>
            <a:off x="9752799" y="5964287"/>
            <a:ext cx="7730614" cy="40711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Graphic 5" descr="Thought bubble with solid fill">
            <a:extLst>
              <a:ext uri="{FF2B5EF4-FFF2-40B4-BE49-F238E27FC236}">
                <a16:creationId xmlns:a16="http://schemas.microsoft.com/office/drawing/2014/main" id="{50766441-355C-475B-9EBF-46360843A52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 rot="10800000" flipH="1">
            <a:off x="9364584" y="952500"/>
            <a:ext cx="8237616" cy="740040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E35AE6B-D8B2-40F5-9296-253972BD522A}"/>
              </a:ext>
            </a:extLst>
          </p:cNvPr>
          <p:cNvSpPr txBox="1"/>
          <p:nvPr/>
        </p:nvSpPr>
        <p:spPr>
          <a:xfrm>
            <a:off x="11125200" y="4418909"/>
            <a:ext cx="4343400" cy="193899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Fat has the most calories. Every gram of fat has 9 calories, that more than TWICE the amount of calories from every gram of protein or carbohydrates</a:t>
            </a:r>
          </a:p>
        </p:txBody>
      </p:sp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 animBg="1"/>
      <p:bldP spid="10" grpId="1" animBg="1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So how can we lose weight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2050" name="Picture 2" descr="Mechanism Of Weight Control – Excellent Slimming And Health, At Our Centre  Or Your Home, Anywhere In The World !">
            <a:extLst>
              <a:ext uri="{FF2B5EF4-FFF2-40B4-BE49-F238E27FC236}">
                <a16:creationId xmlns:a16="http://schemas.microsoft.com/office/drawing/2014/main" id="{12F56F98-075C-41B5-BC53-F56BBA55709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9256" y="1839683"/>
            <a:ext cx="9448800" cy="87028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EB424D6-A28B-49F1-8363-7F1E55AC779F}"/>
              </a:ext>
            </a:extLst>
          </p:cNvPr>
          <p:cNvSpPr txBox="1"/>
          <p:nvPr/>
        </p:nvSpPr>
        <p:spPr>
          <a:xfrm>
            <a:off x="10896600" y="1870958"/>
            <a:ext cx="6874823" cy="8402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200" dirty="0"/>
              <a:t>We aim to reduce our daily calories by at least 500 below the amount we need to MAINTAIN our weight. That way we lose about 1 pound a wee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8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200" dirty="0"/>
              <a:t>We increase our physical activity alongside decreasing our calories to give the calorie balance an extra boos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32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200" dirty="0"/>
              <a:t>Aim for long-term success by finding things you can stick to, but trying new things that improve the health of our daily lifesty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32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200" dirty="0"/>
              <a:t>Don’t fall into the trap of eating more because you exercise more– stick to your calorie plan!</a:t>
            </a:r>
          </a:p>
        </p:txBody>
      </p:sp>
    </p:spTree>
    <p:extLst>
      <p:ext uri="{BB962C8B-B14F-4D97-AF65-F5344CB8AC3E}">
        <p14:creationId xmlns:p14="http://schemas.microsoft.com/office/powerpoint/2010/main" val="22688956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Building on the last month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1FEE5CC-E039-4F19-B498-2B394F5D5FEB}"/>
              </a:ext>
            </a:extLst>
          </p:cNvPr>
          <p:cNvSpPr txBox="1"/>
          <p:nvPr/>
        </p:nvSpPr>
        <p:spPr>
          <a:xfrm>
            <a:off x="1629256" y="2173456"/>
            <a:ext cx="10906891" cy="7417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3600" b="1" dirty="0"/>
              <a:t>OUR ACHIEVABLE GOAL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>
                <a:sym typeface="Wingdings" panose="05000000000000000000" pitchFamily="2" charset="2"/>
              </a:rPr>
              <a:t>Started with 6,000 steps a day with 2,000+ “brisk”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>
                <a:sym typeface="Wingdings" panose="05000000000000000000" pitchFamily="2" charset="2"/>
              </a:rPr>
              <a:t>Aiming for 150 min a week by Week 8 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>
                <a:sym typeface="Wingdings" panose="05000000000000000000" pitchFamily="2" charset="2"/>
              </a:rPr>
              <a:t>That’s about 22 min a day!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Sticking to our calorie goals, and being consistent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Logging calories and exercise everyday so you can track what is working and what is not working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/>
              <a:t>Review your weekly weight change with the intervention team by email to make sure you keep advancing toward your goal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Acknowledge the hard work and success you’ve already had 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US" sz="3200" dirty="0"/>
              <a:t>Maintaining those while we explore mor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US" sz="3200" dirty="0"/>
              <a:t>Achieving 5-7% body weight loss and keeping it off the rest of the yea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2400" dirty="0"/>
          </a:p>
        </p:txBody>
      </p:sp>
      <p:pic>
        <p:nvPicPr>
          <p:cNvPr id="22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6B4C1050-734E-41BB-B1E7-A24606B9F51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5122848" y="2059217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163266D-E4B7-43DB-9596-2862F03CD390}"/>
              </a:ext>
            </a:extLst>
          </p:cNvPr>
          <p:cNvSpPr txBox="1"/>
          <p:nvPr/>
        </p:nvSpPr>
        <p:spPr>
          <a:xfrm>
            <a:off x="14020800" y="4533900"/>
            <a:ext cx="3816672" cy="49552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</a:p>
          <a:p>
            <a:r>
              <a:rPr lang="en-US" sz="3200" b="1" i="1" u="sng" dirty="0">
                <a:solidFill>
                  <a:srgbClr val="FF0000"/>
                </a:solidFill>
              </a:rPr>
              <a:t>Drink water before you eat!</a:t>
            </a:r>
          </a:p>
          <a:p>
            <a:r>
              <a:rPr lang="en-US" sz="2800" dirty="0"/>
              <a:t>Sometimes we mistake thirst for hunger and reach for a snack instead of a glass of water or a calorie-free beverage.  Check in with your thirst before grabbing something to eat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8295452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How am I going to tip the calorie balance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F2CE784-2A40-4CB2-8D1C-8CF36C75FC27}"/>
              </a:ext>
            </a:extLst>
          </p:cNvPr>
          <p:cNvSpPr txBox="1"/>
          <p:nvPr/>
        </p:nvSpPr>
        <p:spPr>
          <a:xfrm>
            <a:off x="1629256" y="2413655"/>
            <a:ext cx="14906144" cy="68941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b="1" u="sng" dirty="0">
                <a:latin typeface="Assistant Regular" charset="-79"/>
                <a:cs typeface="Assistant Regular" charset="-79"/>
              </a:rPr>
              <a:t>What will this week include? (select all)</a:t>
            </a:r>
          </a:p>
          <a:p>
            <a:endParaRPr lang="en-US" sz="18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Drink more water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Start every meal with a salad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Take the long way back on a walk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Jog in place during commercial break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a walking date with a friend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Take an extra loop or two in the grocery stor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Cut out soda and alcohol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Try a new recip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Log my calories and staying on my calorie targe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Getting in my step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Weigh myself everyda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Other (discuss)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9218" name="Picture 2" descr="Why Enterprise SEO Needs a Champion">
            <a:extLst>
              <a:ext uri="{FF2B5EF4-FFF2-40B4-BE49-F238E27FC236}">
                <a16:creationId xmlns:a16="http://schemas.microsoft.com/office/drawing/2014/main" id="{77E00D8C-D5E9-43B6-8787-0468356D9B1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6"/>
          <a:stretch/>
        </p:blipFill>
        <p:spPr bwMode="auto">
          <a:xfrm>
            <a:off x="11277600" y="7150608"/>
            <a:ext cx="5676900" cy="31363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90895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Tip the Energy Balance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weight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sk yourself- can I do another 10 min of exercise today?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Aim to do 30 min more this week than last week (a minimum of 60 min)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Use your activity planner and record your 10min+ successes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Stand more than sit, walk more than stand.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Take the stairs, go on a short walk to kill time– more ideas to get more active? Put them in the chat!</a:t>
            </a: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90518" y="8494466"/>
            <a:ext cx="1276868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REMEMBER 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Drink more water!</a:t>
            </a:r>
          </a:p>
          <a:p>
            <a:r>
              <a:rPr lang="en-US" sz="2800" dirty="0"/>
              <a:t>Fill up on fluids with no calories! Make sure to get enough water in which will make exercise easier and hunger less frequent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32</TotalTime>
  <Words>978</Words>
  <Application>Microsoft Office PowerPoint</Application>
  <PresentationFormat>Custom</PresentationFormat>
  <Paragraphs>162</Paragraphs>
  <Slides>10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20" baseType="lpstr">
      <vt:lpstr>Courier New</vt:lpstr>
      <vt:lpstr>Assistant SemiBold</vt:lpstr>
      <vt:lpstr>Assistant Bold</vt:lpstr>
      <vt:lpstr>Assistant</vt:lpstr>
      <vt:lpstr>Assistant Regular</vt:lpstr>
      <vt:lpstr>Calibri</vt:lpstr>
      <vt:lpstr>Wingdings</vt:lpstr>
      <vt:lpstr>Arial</vt:lpstr>
      <vt:lpstr>Assistant Extra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226</cp:revision>
  <dcterms:created xsi:type="dcterms:W3CDTF">2006-08-16T00:00:00Z</dcterms:created>
  <dcterms:modified xsi:type="dcterms:W3CDTF">2023-11-03T20:47:47Z</dcterms:modified>
  <dc:identifier>DAE7nbwep5o</dc:identifier>
</cp:coreProperties>
</file>